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F4D24-986C-F5F7-2E58-40FCD6E3F3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EDDA5F-7868-48D1-2721-05B65F3F90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AE380F-2337-3EF4-8926-EF1A5CB0D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D2A1BB-6C74-F9A5-33C6-D4B10B337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7D8532-7CC1-1431-8FB9-F78B16264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109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761A9B-610D-1571-4174-9A0E731ED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209323-E068-953C-0C05-A1A57E6BA2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184ED1-CF03-C777-D5BF-093DC8879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BD99E4-A5FB-C173-9E1F-FEEECA080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A07AA3-1A23-9D3F-2E88-986453E0D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35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B5AD12-C76C-CB09-6ADF-A5EAA90CFA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448ACC-4DC0-C6A3-2C2D-E7EA9903F3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B7F7D9-A3AD-C4BD-BC7E-864E9F5AC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7BD15-E2CF-D257-BA68-B169E2687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CD94DC-F36D-D46E-F2F1-6A42741DC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395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D18E0-2803-E59D-DD6C-055DF708E6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B6E7ED-691B-0F14-51AF-30105D40D5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DF3CBB-9155-1A80-A2D2-1565D6D46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22CCEF-930F-19AF-B66B-82F348613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EEC63-C746-06C1-C630-6DE7F8265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365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F87FBE-4FFA-EA97-0A01-C8D52F79A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91D4E6-1562-C05D-0125-CBCFA2FF0E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26DBE-6635-B95C-C7BE-E825FFE97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BAB000-9F86-64E9-81D4-22E377399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E0871C-34DA-9EBA-CA15-0312F8F77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307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C7CB0-F7D3-22FC-CF0C-2FB7AF87C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FA2BBB-8B2D-C462-AF4E-A31DB21610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7A6B34-13EF-EB3F-CADE-A56BCABAC0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F9508D-C5D6-CD1B-A6CD-BE8366D83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DBCD17-40E1-03F4-845E-E47E583C2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68F393-2AEE-97E7-2F87-30E905B25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134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4C685-F600-5406-3A21-AA19975D5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A09E04-BC11-8BD9-FC13-E9F2F990C7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6EE4BB-3AB3-9E47-02EE-CB9FE0FDB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13F4D1-EE91-6C02-8991-761992C480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2CC776-0773-A4AA-DC39-A18A3CBC2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2995D4-F6E2-9278-896D-1A5674581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FF6DB1-9F3D-247B-833D-F87B31443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42D98E-2A3C-1EF9-4F51-030F43265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556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0321F-E662-A54F-4648-F224CCB90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3350AC-1429-D4FA-812D-E4A7F3296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99457A-C439-0C26-731F-C05691450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7BACB6-D352-2712-6ABA-48881A7B2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486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7913F2-6A80-BE20-262E-61E2DE425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733951-60A6-CBA9-EE68-650372853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83F60E-5743-B22C-C654-2CBB4FBAC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475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CF3D0A-02B2-093C-B882-CC160AE68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E76403-413D-7A2F-5C05-A7EE9D784D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F5A328-F0FD-65BC-575F-DBF891EDC0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C4A2E6-84AC-A247-1028-E8661D847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C8E29A-8FAE-14D4-9F19-AECF8B7C3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16C5CC-E5F1-62CF-322C-1219ED651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144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A565B-FCA8-D40A-5805-87C163D73C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ED41B2-EE68-1183-3D21-3CF952388F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84C3EE-076A-2555-58BA-6BA17FABED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3F3854-EE96-BAE2-3E1D-8C5415BA1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0081E2-110E-FE1A-66A0-2F582BDB6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F892FF-69A0-F656-F9FC-C2AB9F366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922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20C788-3CA5-B7B8-649E-98AD208F7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840CBA-21FD-12D4-0B45-335DD90AEA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77E373-FDC5-1101-2EB9-6649BA01F2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F1DA3-DACF-ED49-9D03-116FCB5D4634}" type="datetimeFigureOut">
              <a:rPr lang="en-US" smtClean="0"/>
              <a:t>9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F73B95-9553-CBCC-95B6-CCD5326D0D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CCE937-00F4-60EA-54B2-EAA335380B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B4C5D5-ADCB-4F4D-B731-494C9A28C2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596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CE0396A9-D0AB-4EEF-BEEE-EE48366BAE1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35162" t="41925" r="16740" b="8631"/>
          <a:stretch/>
        </p:blipFill>
        <p:spPr>
          <a:xfrm rot="10800000">
            <a:off x="1006866" y="2875165"/>
            <a:ext cx="4497666" cy="35878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22B1878-7081-4359-8BD5-EB14241ADE4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81" t="21421" r="24235" b="21163"/>
          <a:stretch/>
        </p:blipFill>
        <p:spPr>
          <a:xfrm>
            <a:off x="6298058" y="2732925"/>
            <a:ext cx="4281160" cy="3771162"/>
          </a:xfrm>
          <a:prstGeom prst="rect">
            <a:avLst/>
          </a:prstGeom>
          <a:scene3d>
            <a:camera prst="orthographicFront">
              <a:rot lat="0" lon="10799999" rev="0"/>
            </a:camera>
            <a:lightRig rig="threePt" dir="t"/>
          </a:scene3d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5A321A20-4F41-4CE9-AB40-0E5C30A1B459}"/>
              </a:ext>
            </a:extLst>
          </p:cNvPr>
          <p:cNvGrpSpPr/>
          <p:nvPr/>
        </p:nvGrpSpPr>
        <p:grpSpPr>
          <a:xfrm>
            <a:off x="1463733" y="999098"/>
            <a:ext cx="3881487" cy="1906424"/>
            <a:chOff x="1463733" y="1070218"/>
            <a:chExt cx="3881487" cy="1906424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3A23BB58-26E2-4E6F-B0D8-272228EADA3C}"/>
                </a:ext>
              </a:extLst>
            </p:cNvPr>
            <p:cNvGrpSpPr/>
            <p:nvPr/>
          </p:nvGrpSpPr>
          <p:grpSpPr>
            <a:xfrm>
              <a:off x="2370312" y="1070218"/>
              <a:ext cx="2974908" cy="1906424"/>
              <a:chOff x="2370312" y="1070218"/>
              <a:chExt cx="2974908" cy="1906424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77C4093-9FE0-4542-AE37-0FA6C90E0828}"/>
                  </a:ext>
                </a:extLst>
              </p:cNvPr>
              <p:cNvSpPr txBox="1"/>
              <p:nvPr/>
            </p:nvSpPr>
            <p:spPr>
              <a:xfrm rot="18154926">
                <a:off x="1850534" y="2110389"/>
                <a:ext cx="1386031" cy="346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-a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C7FF845-F4BA-4D7F-BAC8-15749F2E5263}"/>
                  </a:ext>
                </a:extLst>
              </p:cNvPr>
              <p:cNvSpPr txBox="1"/>
              <p:nvPr/>
            </p:nvSpPr>
            <p:spPr>
              <a:xfrm rot="18021703">
                <a:off x="2454869" y="1932502"/>
                <a:ext cx="170087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150uM NR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9D80301-60F7-4A94-A7C9-170157ADC624}"/>
                  </a:ext>
                </a:extLst>
              </p:cNvPr>
              <p:cNvSpPr txBox="1"/>
              <p:nvPr/>
            </p:nvSpPr>
            <p:spPr>
              <a:xfrm rot="18021703">
                <a:off x="3131702" y="1956009"/>
                <a:ext cx="159724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250uM NR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11C57C1-85E1-4148-97E9-3D9E4C33C34B}"/>
                  </a:ext>
                </a:extLst>
              </p:cNvPr>
              <p:cNvSpPr txBox="1"/>
              <p:nvPr/>
            </p:nvSpPr>
            <p:spPr>
              <a:xfrm rot="18021703">
                <a:off x="3700200" y="1849886"/>
                <a:ext cx="189788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500uM NR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AC2F130-CA5A-498C-B5D1-464E299EAB6D}"/>
                  </a:ext>
                </a:extLst>
              </p:cNvPr>
              <p:cNvSpPr txBox="1"/>
              <p:nvPr/>
            </p:nvSpPr>
            <p:spPr>
              <a:xfrm rot="18021703">
                <a:off x="4454534" y="2030917"/>
                <a:ext cx="144281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1mM NR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D7257854-E21A-4E3E-A828-500E2FC58401}"/>
                </a:ext>
              </a:extLst>
            </p:cNvPr>
            <p:cNvGrpSpPr/>
            <p:nvPr/>
          </p:nvGrpSpPr>
          <p:grpSpPr>
            <a:xfrm>
              <a:off x="1463733" y="1445070"/>
              <a:ext cx="3552533" cy="1510247"/>
              <a:chOff x="1463733" y="1445070"/>
              <a:chExt cx="3552533" cy="1510247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C1FF735-ED19-4112-9111-89CB959B6E69}"/>
                  </a:ext>
                </a:extLst>
              </p:cNvPr>
              <p:cNvSpPr txBox="1"/>
              <p:nvPr/>
            </p:nvSpPr>
            <p:spPr>
              <a:xfrm rot="18003121">
                <a:off x="1198158" y="2030917"/>
                <a:ext cx="151024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Untreated</a:t>
                </a:r>
              </a:p>
            </p:txBody>
          </p: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4AB6DD96-7D3D-4434-8838-56CC44273E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63733" y="2882660"/>
                <a:ext cx="43993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513991CA-443B-4EA6-89B3-0205AA631B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94924" y="2877485"/>
                <a:ext cx="43304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A8DC7D24-9189-4C13-B6A6-D60901DD67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36502" y="2876688"/>
                <a:ext cx="535477" cy="79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A9E174C1-F7DF-43BD-99F8-6DDCADD9F0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47304" y="2853076"/>
                <a:ext cx="42261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31C0353D-7614-40E2-81DA-3E88B45BF4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8371" y="2853076"/>
                <a:ext cx="36712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65E71205-29E7-4FFE-836B-10D606DDB3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49144" y="2853076"/>
                <a:ext cx="36712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7F336E48-51BB-4C2D-93C5-DE6E590A21D5}"/>
              </a:ext>
            </a:extLst>
          </p:cNvPr>
          <p:cNvSpPr txBox="1"/>
          <p:nvPr/>
        </p:nvSpPr>
        <p:spPr>
          <a:xfrm>
            <a:off x="5443538" y="3531489"/>
            <a:ext cx="652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AR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16A6ADE-452D-36AC-5145-3380F26A015C}"/>
              </a:ext>
            </a:extLst>
          </p:cNvPr>
          <p:cNvGrpSpPr/>
          <p:nvPr/>
        </p:nvGrpSpPr>
        <p:grpSpPr>
          <a:xfrm>
            <a:off x="6781169" y="826879"/>
            <a:ext cx="3590160" cy="1906046"/>
            <a:chOff x="1463733" y="1070596"/>
            <a:chExt cx="3590160" cy="1906046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E8689C34-D2E4-E2B3-258F-2B6DE5F8D96E}"/>
                </a:ext>
              </a:extLst>
            </p:cNvPr>
            <p:cNvGrpSpPr/>
            <p:nvPr/>
          </p:nvGrpSpPr>
          <p:grpSpPr>
            <a:xfrm>
              <a:off x="2370312" y="1070596"/>
              <a:ext cx="2683581" cy="1906046"/>
              <a:chOff x="2370312" y="1070596"/>
              <a:chExt cx="2683581" cy="1906046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563C20C2-E414-59D1-132C-165FEE89378F}"/>
                  </a:ext>
                </a:extLst>
              </p:cNvPr>
              <p:cNvSpPr txBox="1"/>
              <p:nvPr/>
            </p:nvSpPr>
            <p:spPr>
              <a:xfrm rot="18154926">
                <a:off x="1850534" y="2110389"/>
                <a:ext cx="1386031" cy="346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-a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DC208B8D-C2D0-6331-CCD8-C0F7B280CA08}"/>
                  </a:ext>
                </a:extLst>
              </p:cNvPr>
              <p:cNvSpPr txBox="1"/>
              <p:nvPr/>
            </p:nvSpPr>
            <p:spPr>
              <a:xfrm rot="18021703">
                <a:off x="2454869" y="1932502"/>
                <a:ext cx="170087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150uM NR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BEC23459-6C67-E187-4122-2B2A626CA5E7}"/>
                  </a:ext>
                </a:extLst>
              </p:cNvPr>
              <p:cNvSpPr txBox="1"/>
              <p:nvPr/>
            </p:nvSpPr>
            <p:spPr>
              <a:xfrm rot="18021703">
                <a:off x="3033658" y="1971406"/>
                <a:ext cx="159724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250uM NR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630E5861-C0A2-31D1-160D-BCB0EA68A17C}"/>
                  </a:ext>
                </a:extLst>
              </p:cNvPr>
              <p:cNvSpPr txBox="1"/>
              <p:nvPr/>
            </p:nvSpPr>
            <p:spPr>
              <a:xfrm rot="18021703">
                <a:off x="3509888" y="1850264"/>
                <a:ext cx="189788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500uM NR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CB598811-88AF-098D-F01A-DEC06D292096}"/>
                  </a:ext>
                </a:extLst>
              </p:cNvPr>
              <p:cNvSpPr txBox="1"/>
              <p:nvPr/>
            </p:nvSpPr>
            <p:spPr>
              <a:xfrm rot="18021703">
                <a:off x="4166766" y="1997492"/>
                <a:ext cx="14357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TNFa+1mM NR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F23EFCF8-84B5-F242-E41F-CF592245D555}"/>
                </a:ext>
              </a:extLst>
            </p:cNvPr>
            <p:cNvGrpSpPr/>
            <p:nvPr/>
          </p:nvGrpSpPr>
          <p:grpSpPr>
            <a:xfrm>
              <a:off x="1463733" y="1445070"/>
              <a:ext cx="3285404" cy="1510247"/>
              <a:chOff x="1463733" y="1445070"/>
              <a:chExt cx="3285404" cy="1510247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A33FEED-52F1-F156-E0D6-729A294849E1}"/>
                  </a:ext>
                </a:extLst>
              </p:cNvPr>
              <p:cNvSpPr txBox="1"/>
              <p:nvPr/>
            </p:nvSpPr>
            <p:spPr>
              <a:xfrm rot="18003121">
                <a:off x="1198158" y="2030917"/>
                <a:ext cx="151024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dirty="0"/>
                  <a:t>Untreated</a:t>
                </a: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ECBD30A6-6E11-47B2-7AC1-01FC11D881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63733" y="2882660"/>
                <a:ext cx="43993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6F72610A-D50F-9DA8-7CD8-9A3F858570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94924" y="2877485"/>
                <a:ext cx="43304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47DC23E8-F45E-D600-F3A7-30A0D7E6937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36502" y="2876688"/>
                <a:ext cx="535477" cy="79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A70C0D30-155D-245C-28C6-5CACDD4178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32282" y="2853076"/>
                <a:ext cx="42261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DA530097-E9AD-7F28-84F4-4271ADA19DC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70052" y="2853076"/>
                <a:ext cx="36712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C49F6DBF-AF8C-6E49-DEBF-F5414BED6F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82015" y="2853076"/>
                <a:ext cx="36712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8BC95FB7-9748-CCB7-E17F-146CA80ADC9D}"/>
              </a:ext>
            </a:extLst>
          </p:cNvPr>
          <p:cNvSpPr txBox="1"/>
          <p:nvPr/>
        </p:nvSpPr>
        <p:spPr>
          <a:xfrm>
            <a:off x="10579218" y="4196375"/>
            <a:ext cx="1196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Stain-free</a:t>
            </a:r>
          </a:p>
        </p:txBody>
      </p:sp>
      <p:sp>
        <p:nvSpPr>
          <p:cNvPr id="55" name="Title 1">
            <a:extLst>
              <a:ext uri="{FF2B5EF4-FFF2-40B4-BE49-F238E27FC236}">
                <a16:creationId xmlns:a16="http://schemas.microsoft.com/office/drawing/2014/main" id="{4BEE04CF-4146-43FC-3DB5-DEDBE3C83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5479"/>
            <a:ext cx="10515600" cy="1325563"/>
          </a:xfrm>
        </p:spPr>
        <p:txBody>
          <a:bodyPr>
            <a:normAutofit/>
          </a:bodyPr>
          <a:lstStyle/>
          <a:p>
            <a:r>
              <a:rPr lang="en-CA" sz="3000" b="0" i="0" dirty="0">
                <a:solidFill>
                  <a:srgbClr val="000000"/>
                </a:solidFill>
                <a:effectLst/>
                <a:latin typeface="Verdana" panose="020B0604030504040204" pitchFamily="34" charset="0"/>
              </a:rPr>
              <a:t>Full unedited blot for Figure 2A</a:t>
            </a:r>
            <a:endParaRPr lang="en-CA" sz="30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F40293-A733-7408-0516-C071ABB26DF6}"/>
              </a:ext>
            </a:extLst>
          </p:cNvPr>
          <p:cNvSpPr/>
          <p:nvPr/>
        </p:nvSpPr>
        <p:spPr>
          <a:xfrm>
            <a:off x="1327337" y="3413112"/>
            <a:ext cx="3914143" cy="293688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03804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Verdana</vt:lpstr>
      <vt:lpstr>Office Theme</vt:lpstr>
      <vt:lpstr>Full unedited blot for Figure 2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han, Fahmida</dc:creator>
  <cp:lastModifiedBy>Shannon Bainbridge-Whiteside</cp:lastModifiedBy>
  <cp:revision>1</cp:revision>
  <dcterms:created xsi:type="dcterms:W3CDTF">2024-09-20T13:17:33Z</dcterms:created>
  <dcterms:modified xsi:type="dcterms:W3CDTF">2024-09-23T13:26:42Z</dcterms:modified>
</cp:coreProperties>
</file>